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058" y="-2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995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36056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15072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3476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7096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83500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4561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3297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731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932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1115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7AB07-F329-47F3-9C23-F961A3154B0D}" type="datetimeFigureOut">
              <a:rPr lang="en-IN" smtClean="0"/>
              <a:t>24-05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C0811-AA9E-42EE-B563-D47CF7AC0F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2011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1050874" y="5013176"/>
            <a:ext cx="72655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ure S1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patial</a:t>
            </a:r>
            <a:r>
              <a:rPr lang="en-I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istribution of (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) Aridity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dex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(b) Precipitation of driest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quarter (mm),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I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otential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vapotranspiration (mm), (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) Temperature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easonality (</a:t>
            </a:r>
            <a:r>
              <a:rPr lang="en-IN" sz="12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ofV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), (e) Human appropriation of net primary productivity </a:t>
            </a:r>
            <a:r>
              <a:rPr lang="en-IN" sz="1200" dirty="0" smtClean="0"/>
              <a:t>(</a:t>
            </a:r>
            <a:r>
              <a:rPr lang="en-IN" sz="1200" dirty="0" err="1" smtClean="0"/>
              <a:t>Pg</a:t>
            </a:r>
            <a:r>
              <a:rPr lang="en-IN" sz="1200" dirty="0" smtClean="0"/>
              <a:t> C/</a:t>
            </a:r>
            <a:r>
              <a:rPr lang="en-IN" sz="1200" dirty="0" err="1" smtClean="0"/>
              <a:t>yr</a:t>
            </a:r>
            <a:r>
              <a:rPr lang="en-IN" sz="1200" dirty="0" smtClean="0"/>
              <a:t>)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lobal human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ootprint (/ha), (g)</a:t>
            </a:r>
            <a:r>
              <a:rPr lang="en-IN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lope (</a:t>
            </a:r>
            <a:r>
              <a:rPr lang="en-IN" sz="1200" dirty="0">
                <a:solidFill>
                  <a:prstClr val="black"/>
                </a:solidFill>
                <a:latin typeface="Aharoni"/>
                <a:cs typeface="Aharoni"/>
              </a:rPr>
              <a:t>°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) and (h) Terrain </a:t>
            </a:r>
            <a:r>
              <a:rPr lang="en-I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uggedness </a:t>
            </a:r>
            <a:r>
              <a:rPr lang="en-I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dex </a:t>
            </a:r>
          </a:p>
        </p:txBody>
      </p:sp>
      <p:grpSp>
        <p:nvGrpSpPr>
          <p:cNvPr id="1036" name="Group 1035"/>
          <p:cNvGrpSpPr/>
          <p:nvPr/>
        </p:nvGrpSpPr>
        <p:grpSpPr>
          <a:xfrm>
            <a:off x="932365" y="1320508"/>
            <a:ext cx="7404031" cy="3568590"/>
            <a:chOff x="932365" y="1320508"/>
            <a:chExt cx="7404031" cy="3568590"/>
          </a:xfrm>
        </p:grpSpPr>
        <p:grpSp>
          <p:nvGrpSpPr>
            <p:cNvPr id="1034" name="Group 1033"/>
            <p:cNvGrpSpPr/>
            <p:nvPr/>
          </p:nvGrpSpPr>
          <p:grpSpPr>
            <a:xfrm>
              <a:off x="932365" y="1320508"/>
              <a:ext cx="7384051" cy="1676444"/>
              <a:chOff x="619687" y="742705"/>
              <a:chExt cx="7384051" cy="1676444"/>
            </a:xfrm>
          </p:grpSpPr>
          <p:grpSp>
            <p:nvGrpSpPr>
              <p:cNvPr id="1028" name="Group 1027"/>
              <p:cNvGrpSpPr/>
              <p:nvPr/>
            </p:nvGrpSpPr>
            <p:grpSpPr>
              <a:xfrm>
                <a:off x="619687" y="768842"/>
                <a:ext cx="1916706" cy="1643934"/>
                <a:chOff x="619687" y="768842"/>
                <a:chExt cx="1916706" cy="1643934"/>
              </a:xfrm>
            </p:grpSpPr>
            <p:grpSp>
              <p:nvGrpSpPr>
                <p:cNvPr id="17" name="Group 16"/>
                <p:cNvGrpSpPr/>
                <p:nvPr/>
              </p:nvGrpSpPr>
              <p:grpSpPr>
                <a:xfrm>
                  <a:off x="736393" y="768842"/>
                  <a:ext cx="1800000" cy="1643934"/>
                  <a:chOff x="539552" y="768842"/>
                  <a:chExt cx="1800000" cy="1643934"/>
                </a:xfrm>
              </p:grpSpPr>
              <p:pic>
                <p:nvPicPr>
                  <p:cNvPr id="1030" name="Picture 6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629" t="16430" r="3770" b="16201"/>
                  <a:stretch/>
                </p:blipFill>
                <p:spPr bwMode="auto">
                  <a:xfrm>
                    <a:off x="539552" y="768842"/>
                    <a:ext cx="1800000" cy="164393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3" name="Group 2"/>
                  <p:cNvGrpSpPr/>
                  <p:nvPr/>
                </p:nvGrpSpPr>
                <p:grpSpPr>
                  <a:xfrm>
                    <a:off x="539554" y="1772816"/>
                    <a:ext cx="883278" cy="576000"/>
                    <a:chOff x="1402969" y="2361139"/>
                    <a:chExt cx="1145551" cy="576000"/>
                  </a:xfrm>
                </p:grpSpPr>
                <p:pic>
                  <p:nvPicPr>
                    <p:cNvPr id="1031" name="Picture 7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3678" r="73103" b="24183"/>
                    <a:stretch/>
                  </p:blipFill>
                  <p:spPr bwMode="auto">
                    <a:xfrm>
                      <a:off x="1402969" y="2433147"/>
                      <a:ext cx="191238" cy="468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5" name="TextBox 4"/>
                    <p:cNvSpPr txBox="1"/>
                    <p:nvPr/>
                  </p:nvSpPr>
                  <p:spPr>
                    <a:xfrm>
                      <a:off x="1480617" y="2361139"/>
                      <a:ext cx="1067903" cy="57600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High: 0.454</a:t>
                      </a:r>
                    </a:p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Low: 0.043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</p:grpSp>
            <p:sp>
              <p:nvSpPr>
                <p:cNvPr id="2" name="TextBox 1"/>
                <p:cNvSpPr txBox="1"/>
                <p:nvPr/>
              </p:nvSpPr>
              <p:spPr>
                <a:xfrm>
                  <a:off x="619687" y="1577740"/>
                  <a:ext cx="327267" cy="2368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itchFamily="18" charset="0"/>
                      <a:cs typeface="Times New Roman" pitchFamily="18" charset="0"/>
                    </a:rPr>
                    <a:t>(a)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029" name="Group 1028"/>
              <p:cNvGrpSpPr/>
              <p:nvPr/>
            </p:nvGrpSpPr>
            <p:grpSpPr>
              <a:xfrm>
                <a:off x="2492257" y="742705"/>
                <a:ext cx="1863919" cy="1639138"/>
                <a:chOff x="2492257" y="742705"/>
                <a:chExt cx="1863919" cy="1639138"/>
              </a:xfrm>
            </p:grpSpPr>
            <p:grpSp>
              <p:nvGrpSpPr>
                <p:cNvPr id="29" name="Group 28"/>
                <p:cNvGrpSpPr/>
                <p:nvPr/>
              </p:nvGrpSpPr>
              <p:grpSpPr>
                <a:xfrm>
                  <a:off x="2556176" y="742705"/>
                  <a:ext cx="1800000" cy="1639138"/>
                  <a:chOff x="2359335" y="742706"/>
                  <a:chExt cx="1800000" cy="1598748"/>
                </a:xfrm>
              </p:grpSpPr>
              <p:pic>
                <p:nvPicPr>
                  <p:cNvPr id="8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319" t="16558" r="3771" b="16073"/>
                  <a:stretch/>
                </p:blipFill>
                <p:spPr bwMode="auto">
                  <a:xfrm>
                    <a:off x="2359335" y="742706"/>
                    <a:ext cx="1800000" cy="159874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4" name="Group 3"/>
                  <p:cNvGrpSpPr/>
                  <p:nvPr/>
                </p:nvGrpSpPr>
                <p:grpSpPr>
                  <a:xfrm>
                    <a:off x="2414295" y="1738742"/>
                    <a:ext cx="641612" cy="561807"/>
                    <a:chOff x="4631186" y="2320733"/>
                    <a:chExt cx="821936" cy="561807"/>
                  </a:xfrm>
                </p:grpSpPr>
                <p:pic>
                  <p:nvPicPr>
                    <p:cNvPr id="9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4023" r="68199" b="26158"/>
                    <a:stretch/>
                  </p:blipFill>
                  <p:spPr bwMode="auto">
                    <a:xfrm>
                      <a:off x="4631186" y="2399659"/>
                      <a:ext cx="184471" cy="45634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4690496" y="2320733"/>
                      <a:ext cx="762626" cy="56180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High: 209</a:t>
                      </a:r>
                    </a:p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Low: 31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</p:grpSp>
            <p:sp>
              <p:nvSpPr>
                <p:cNvPr id="11" name="TextBox 10"/>
                <p:cNvSpPr txBox="1"/>
                <p:nvPr/>
              </p:nvSpPr>
              <p:spPr>
                <a:xfrm>
                  <a:off x="2492257" y="1577740"/>
                  <a:ext cx="398913" cy="2368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itchFamily="18" charset="0"/>
                      <a:cs typeface="Times New Roman" pitchFamily="18" charset="0"/>
                    </a:rPr>
                    <a:t>(b)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032" name="Group 1031"/>
              <p:cNvGrpSpPr/>
              <p:nvPr/>
            </p:nvGrpSpPr>
            <p:grpSpPr>
              <a:xfrm>
                <a:off x="4298670" y="768842"/>
                <a:ext cx="1857506" cy="1650307"/>
                <a:chOff x="4298670" y="768842"/>
                <a:chExt cx="1857506" cy="1650307"/>
              </a:xfrm>
            </p:grpSpPr>
            <p:grpSp>
              <p:nvGrpSpPr>
                <p:cNvPr id="1026" name="Group 1025"/>
                <p:cNvGrpSpPr/>
                <p:nvPr/>
              </p:nvGrpSpPr>
              <p:grpSpPr>
                <a:xfrm>
                  <a:off x="4356176" y="768842"/>
                  <a:ext cx="1800000" cy="1650307"/>
                  <a:chOff x="4159335" y="768842"/>
                  <a:chExt cx="1800000" cy="1650307"/>
                </a:xfrm>
              </p:grpSpPr>
              <p:pic>
                <p:nvPicPr>
                  <p:cNvPr id="13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90" t="16297" r="4200" b="16335"/>
                  <a:stretch/>
                </p:blipFill>
                <p:spPr bwMode="auto">
                  <a:xfrm>
                    <a:off x="4159335" y="768842"/>
                    <a:ext cx="1800000" cy="1650307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4211961" y="1772816"/>
                    <a:ext cx="887533" cy="646331"/>
                    <a:chOff x="1543517" y="5046619"/>
                    <a:chExt cx="1007127" cy="646331"/>
                  </a:xfrm>
                </p:grpSpPr>
                <p:pic>
                  <p:nvPicPr>
                    <p:cNvPr id="15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2071" r="68698" b="24411"/>
                    <a:stretch/>
                  </p:blipFill>
                  <p:spPr bwMode="auto">
                    <a:xfrm>
                      <a:off x="1543517" y="5100666"/>
                      <a:ext cx="192000" cy="47685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24" name="TextBox 23"/>
                    <p:cNvSpPr txBox="1"/>
                    <p:nvPr/>
                  </p:nvSpPr>
                  <p:spPr>
                    <a:xfrm>
                      <a:off x="1593482" y="5046619"/>
                      <a:ext cx="957162" cy="64633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High:1639</a:t>
                      </a:r>
                    </a:p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Low: 141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</p:grpSp>
            <p:sp>
              <p:nvSpPr>
                <p:cNvPr id="16" name="TextBox 15"/>
                <p:cNvSpPr txBox="1"/>
                <p:nvPr/>
              </p:nvSpPr>
              <p:spPr>
                <a:xfrm>
                  <a:off x="4298670" y="1570386"/>
                  <a:ext cx="392700" cy="2442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itchFamily="18" charset="0"/>
                      <a:cs typeface="Times New Roman" pitchFamily="18" charset="0"/>
                    </a:rPr>
                    <a:t>(c)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033" name="Group 1032"/>
              <p:cNvGrpSpPr/>
              <p:nvPr/>
            </p:nvGrpSpPr>
            <p:grpSpPr>
              <a:xfrm>
                <a:off x="6088573" y="750378"/>
                <a:ext cx="1915165" cy="1634962"/>
                <a:chOff x="6088573" y="750378"/>
                <a:chExt cx="1915165" cy="1634962"/>
              </a:xfrm>
            </p:grpSpPr>
            <p:grpSp>
              <p:nvGrpSpPr>
                <p:cNvPr id="1027" name="Group 1026"/>
                <p:cNvGrpSpPr/>
                <p:nvPr/>
              </p:nvGrpSpPr>
              <p:grpSpPr>
                <a:xfrm>
                  <a:off x="6203738" y="750378"/>
                  <a:ext cx="1800000" cy="1634962"/>
                  <a:chOff x="6203738" y="750378"/>
                  <a:chExt cx="1800000" cy="1634962"/>
                </a:xfrm>
              </p:grpSpPr>
              <p:pic>
                <p:nvPicPr>
                  <p:cNvPr id="18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628" t="16430" r="3599" b="16201"/>
                  <a:stretch/>
                </p:blipFill>
                <p:spPr bwMode="auto">
                  <a:xfrm>
                    <a:off x="6203738" y="750378"/>
                    <a:ext cx="1800000" cy="1634962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6228180" y="1760696"/>
                    <a:ext cx="875557" cy="576000"/>
                    <a:chOff x="4492767" y="4977948"/>
                    <a:chExt cx="987104" cy="576000"/>
                  </a:xfrm>
                </p:grpSpPr>
                <p:pic>
                  <p:nvPicPr>
                    <p:cNvPr id="19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3241" r="69060" b="24793"/>
                    <a:stretch/>
                  </p:blipFill>
                  <p:spPr bwMode="auto">
                    <a:xfrm>
                      <a:off x="4492767" y="5078370"/>
                      <a:ext cx="190756" cy="4536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4559426" y="4977948"/>
                      <a:ext cx="920445" cy="57600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High: 828.8</a:t>
                      </a:r>
                    </a:p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Low: 444.0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</p:grpSp>
            <p:sp>
              <p:nvSpPr>
                <p:cNvPr id="21" name="TextBox 20"/>
                <p:cNvSpPr txBox="1"/>
                <p:nvPr/>
              </p:nvSpPr>
              <p:spPr>
                <a:xfrm>
                  <a:off x="6088573" y="1577739"/>
                  <a:ext cx="366721" cy="2368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dirty="0" smtClean="0">
                      <a:latin typeface="Times New Roman" pitchFamily="18" charset="0"/>
                      <a:cs typeface="Times New Roman" pitchFamily="18" charset="0"/>
                    </a:rPr>
                    <a:t>(d)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grpSp>
          <p:nvGrpSpPr>
            <p:cNvPr id="1035" name="Group 1034"/>
            <p:cNvGrpSpPr/>
            <p:nvPr/>
          </p:nvGrpSpPr>
          <p:grpSpPr>
            <a:xfrm>
              <a:off x="956396" y="3212976"/>
              <a:ext cx="7380000" cy="1676122"/>
              <a:chOff x="956396" y="3356992"/>
              <a:chExt cx="7239012" cy="1676122"/>
            </a:xfrm>
          </p:grpSpPr>
          <p:grpSp>
            <p:nvGrpSpPr>
              <p:cNvPr id="43" name="Group 42"/>
              <p:cNvGrpSpPr/>
              <p:nvPr/>
            </p:nvGrpSpPr>
            <p:grpSpPr>
              <a:xfrm>
                <a:off x="995408" y="3356992"/>
                <a:ext cx="1800000" cy="1656185"/>
                <a:chOff x="1512000" y="729280"/>
                <a:chExt cx="2904056" cy="2495123"/>
              </a:xfrm>
            </p:grpSpPr>
            <p:pic>
              <p:nvPicPr>
                <p:cNvPr id="44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849" t="38022" r="12057" b="21639"/>
                <a:stretch/>
              </p:blipFill>
              <p:spPr bwMode="auto">
                <a:xfrm>
                  <a:off x="1512000" y="729280"/>
                  <a:ext cx="2904056" cy="248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45" name="Group 44"/>
                <p:cNvGrpSpPr/>
                <p:nvPr/>
              </p:nvGrpSpPr>
              <p:grpSpPr>
                <a:xfrm>
                  <a:off x="1598574" y="2250675"/>
                  <a:ext cx="1473682" cy="973728"/>
                  <a:chOff x="1598574" y="2250675"/>
                  <a:chExt cx="1473682" cy="973728"/>
                </a:xfrm>
              </p:grpSpPr>
              <p:pic>
                <p:nvPicPr>
                  <p:cNvPr id="46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9097" r="78876" b="18140"/>
                  <a:stretch/>
                </p:blipFill>
                <p:spPr bwMode="auto">
                  <a:xfrm>
                    <a:off x="1598574" y="2410853"/>
                    <a:ext cx="237902" cy="70506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1736390" y="2250675"/>
                    <a:ext cx="1335866" cy="97372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High: 190</a:t>
                    </a:r>
                  </a:p>
                  <a:p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Low: 0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grpSp>
            <p:nvGrpSpPr>
              <p:cNvPr id="48" name="Group 47"/>
              <p:cNvGrpSpPr/>
              <p:nvPr/>
            </p:nvGrpSpPr>
            <p:grpSpPr>
              <a:xfrm>
                <a:off x="2795408" y="3384313"/>
                <a:ext cx="1800000" cy="1648801"/>
                <a:chOff x="4597585" y="729280"/>
                <a:chExt cx="2885557" cy="2484000"/>
              </a:xfrm>
            </p:grpSpPr>
            <p:pic>
              <p:nvPicPr>
                <p:cNvPr id="49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034" t="38022" r="12242" b="21639"/>
                <a:stretch/>
              </p:blipFill>
              <p:spPr bwMode="auto">
                <a:xfrm>
                  <a:off x="4597585" y="729280"/>
                  <a:ext cx="2885557" cy="248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50" name="Group 49"/>
                <p:cNvGrpSpPr/>
                <p:nvPr/>
              </p:nvGrpSpPr>
              <p:grpSpPr>
                <a:xfrm>
                  <a:off x="4803431" y="2209513"/>
                  <a:ext cx="1384832" cy="973730"/>
                  <a:chOff x="4803431" y="2209513"/>
                  <a:chExt cx="1384832" cy="973730"/>
                </a:xfrm>
              </p:grpSpPr>
              <p:pic>
                <p:nvPicPr>
                  <p:cNvPr id="51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4598" r="69143" b="15503"/>
                  <a:stretch/>
                </p:blipFill>
                <p:spPr bwMode="auto">
                  <a:xfrm>
                    <a:off x="4803431" y="2349758"/>
                    <a:ext cx="230845" cy="725002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4954721" y="2209513"/>
                    <a:ext cx="1233542" cy="97373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High: 93</a:t>
                    </a:r>
                  </a:p>
                  <a:p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Low: 0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grpSp>
            <p:nvGrpSpPr>
              <p:cNvPr id="53" name="Group 52"/>
              <p:cNvGrpSpPr/>
              <p:nvPr/>
            </p:nvGrpSpPr>
            <p:grpSpPr>
              <a:xfrm>
                <a:off x="6395408" y="3356992"/>
                <a:ext cx="1800000" cy="1648800"/>
                <a:chOff x="4560746" y="3341520"/>
                <a:chExt cx="3071254" cy="2607760"/>
              </a:xfrm>
            </p:grpSpPr>
            <p:pic>
              <p:nvPicPr>
                <p:cNvPr id="54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849" t="38573" r="12427" b="21639"/>
                <a:stretch/>
              </p:blipFill>
              <p:spPr bwMode="auto">
                <a:xfrm>
                  <a:off x="4560746" y="3341520"/>
                  <a:ext cx="3071254" cy="26077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55" name="Group 54"/>
                <p:cNvGrpSpPr/>
                <p:nvPr/>
              </p:nvGrpSpPr>
              <p:grpSpPr>
                <a:xfrm>
                  <a:off x="4644010" y="4824826"/>
                  <a:ext cx="1701171" cy="1022244"/>
                  <a:chOff x="4644010" y="4824826"/>
                  <a:chExt cx="1701171" cy="1022244"/>
                </a:xfrm>
              </p:grpSpPr>
              <p:pic>
                <p:nvPicPr>
                  <p:cNvPr id="56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3099" r="71883" b="18916"/>
                  <a:stretch/>
                </p:blipFill>
                <p:spPr bwMode="auto">
                  <a:xfrm>
                    <a:off x="4644010" y="4992988"/>
                    <a:ext cx="265795" cy="74019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4793349" y="4824826"/>
                    <a:ext cx="1551832" cy="10222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High: 3865</a:t>
                    </a:r>
                  </a:p>
                  <a:p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Low: 0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grpSp>
            <p:nvGrpSpPr>
              <p:cNvPr id="58" name="Group 57"/>
              <p:cNvGrpSpPr/>
              <p:nvPr/>
            </p:nvGrpSpPr>
            <p:grpSpPr>
              <a:xfrm>
                <a:off x="4595408" y="3384313"/>
                <a:ext cx="1800000" cy="1648800"/>
                <a:chOff x="1535280" y="3337620"/>
                <a:chExt cx="3025466" cy="2607760"/>
              </a:xfrm>
            </p:grpSpPr>
            <p:pic>
              <p:nvPicPr>
                <p:cNvPr id="59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219" t="38573" r="12057" b="21776"/>
                <a:stretch/>
              </p:blipFill>
              <p:spPr bwMode="auto">
                <a:xfrm>
                  <a:off x="1535280" y="3337620"/>
                  <a:ext cx="3025466" cy="26077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60" name="Group 59"/>
                <p:cNvGrpSpPr/>
                <p:nvPr/>
              </p:nvGrpSpPr>
              <p:grpSpPr>
                <a:xfrm>
                  <a:off x="1562182" y="4777714"/>
                  <a:ext cx="1472127" cy="1022244"/>
                  <a:chOff x="1562182" y="4777714"/>
                  <a:chExt cx="1472127" cy="1022244"/>
                </a:xfrm>
              </p:grpSpPr>
              <p:pic>
                <p:nvPicPr>
                  <p:cNvPr id="61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52672" r="72152" b="19936"/>
                  <a:stretch/>
                </p:blipFill>
                <p:spPr bwMode="auto">
                  <a:xfrm>
                    <a:off x="1562182" y="4945876"/>
                    <a:ext cx="259012" cy="74019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62" name="TextBox 61"/>
                  <p:cNvSpPr txBox="1"/>
                  <p:nvPr/>
                </p:nvSpPr>
                <p:spPr>
                  <a:xfrm>
                    <a:off x="1752592" y="4777714"/>
                    <a:ext cx="1281717" cy="10222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High: 48</a:t>
                    </a:r>
                  </a:p>
                  <a:p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Low: 0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sp>
            <p:nvSpPr>
              <p:cNvPr id="63" name="TextBox 62"/>
              <p:cNvSpPr txBox="1"/>
              <p:nvPr/>
            </p:nvSpPr>
            <p:spPr>
              <a:xfrm>
                <a:off x="2808631" y="4070212"/>
                <a:ext cx="3989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(f)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956396" y="4070213"/>
                <a:ext cx="3561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(e)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6300192" y="4106616"/>
                <a:ext cx="3667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(h)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4538041" y="4106617"/>
                <a:ext cx="3927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>
                    <a:latin typeface="Times New Roman" pitchFamily="18" charset="0"/>
                    <a:cs typeface="Times New Roman" pitchFamily="18" charset="0"/>
                  </a:rPr>
                  <a:t>(g)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6" name="TextBox 5"/>
          <p:cNvSpPr txBox="1"/>
          <p:nvPr/>
        </p:nvSpPr>
        <p:spPr>
          <a:xfrm>
            <a:off x="3940641" y="532711"/>
            <a:ext cx="1305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000" b="1" smtClean="0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en-IN" sz="2000" smtClean="0">
                <a:latin typeface="Times New Roman" pitchFamily="18" charset="0"/>
                <a:cs typeface="Times New Roman" pitchFamily="18" charset="0"/>
              </a:rPr>
              <a:t>  S2</a:t>
            </a:r>
            <a:endParaRPr lang="en-IN" sz="2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2461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</TotalTime>
  <Words>143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MP</dc:creator>
  <cp:lastModifiedBy>RMP</cp:lastModifiedBy>
  <cp:revision>29</cp:revision>
  <dcterms:created xsi:type="dcterms:W3CDTF">2016-12-06T06:52:23Z</dcterms:created>
  <dcterms:modified xsi:type="dcterms:W3CDTF">2017-05-24T10:04:03Z</dcterms:modified>
</cp:coreProperties>
</file>